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95" d="100"/>
          <a:sy n="95" d="100"/>
        </p:scale>
        <p:origin x="95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18657-0DCF-4881-A78D-C7BF4CF64AC3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AA274-1447-4770-9B6A-B8AB5FBF1CD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508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18657-0DCF-4881-A78D-C7BF4CF64AC3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AA274-1447-4770-9B6A-B8AB5FBF1CD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814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18657-0DCF-4881-A78D-C7BF4CF64AC3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AA274-1447-4770-9B6A-B8AB5FBF1CD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3025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18657-0DCF-4881-A78D-C7BF4CF64AC3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AA274-1447-4770-9B6A-B8AB5FBF1CD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1296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18657-0DCF-4881-A78D-C7BF4CF64AC3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AA274-1447-4770-9B6A-B8AB5FBF1CD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564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18657-0DCF-4881-A78D-C7BF4CF64AC3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AA274-1447-4770-9B6A-B8AB5FBF1CD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3217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18657-0DCF-4881-A78D-C7BF4CF64AC3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AA274-1447-4770-9B6A-B8AB5FBF1CD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82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18657-0DCF-4881-A78D-C7BF4CF64AC3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AA274-1447-4770-9B6A-B8AB5FBF1CD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3579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18657-0DCF-4881-A78D-C7BF4CF64AC3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AA274-1447-4770-9B6A-B8AB5FBF1CD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3485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18657-0DCF-4881-A78D-C7BF4CF64AC3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AA274-1447-4770-9B6A-B8AB5FBF1CD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757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718657-0DCF-4881-A78D-C7BF4CF64AC3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AA274-1447-4770-9B6A-B8AB5FBF1CD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4287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718657-0DCF-4881-A78D-C7BF4CF64AC3}" type="datetimeFigureOut">
              <a:rPr lang="en-US" smtClean="0"/>
              <a:t>3/2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AA274-1447-4770-9B6A-B8AB5FBF1CD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08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2"/>
          <p:cNvSpPr txBox="1">
            <a:spLocks noChangeArrowheads="1"/>
          </p:cNvSpPr>
          <p:nvPr/>
        </p:nvSpPr>
        <p:spPr bwMode="auto">
          <a:xfrm>
            <a:off x="742107" y="303213"/>
            <a:ext cx="6020494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de-DE" altLang="en-US"/>
              <a:t>Ilei protein expression in KH2-Ilei ES cells after dox-stimulation</a:t>
            </a:r>
          </a:p>
        </p:txBody>
      </p:sp>
      <p:sp>
        <p:nvSpPr>
          <p:cNvPr id="6" name="Text Box 6"/>
          <p:cNvSpPr txBox="1">
            <a:spLocks noChangeArrowheads="1"/>
          </p:cNvSpPr>
          <p:nvPr/>
        </p:nvSpPr>
        <p:spPr bwMode="auto">
          <a:xfrm>
            <a:off x="605582" y="3581401"/>
            <a:ext cx="311399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de-DE" altLang="en-US" sz="1200"/>
              <a:t>Same Blot with Bethyl FLAG diff. Exposure time</a:t>
            </a:r>
          </a:p>
        </p:txBody>
      </p:sp>
      <p:sp>
        <p:nvSpPr>
          <p:cNvPr id="7" name="Text Box 7"/>
          <p:cNvSpPr txBox="1">
            <a:spLocks noChangeArrowheads="1"/>
          </p:cNvSpPr>
          <p:nvPr/>
        </p:nvSpPr>
        <p:spPr bwMode="auto">
          <a:xfrm>
            <a:off x="4415583" y="2286000"/>
            <a:ext cx="5365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de-DE" altLang="en-US" sz="1200"/>
              <a:t>8 min</a:t>
            </a:r>
          </a:p>
        </p:txBody>
      </p:sp>
      <p:sp>
        <p:nvSpPr>
          <p:cNvPr id="8" name="Text Box 8"/>
          <p:cNvSpPr txBox="1">
            <a:spLocks noChangeArrowheads="1"/>
          </p:cNvSpPr>
          <p:nvPr/>
        </p:nvSpPr>
        <p:spPr bwMode="auto">
          <a:xfrm>
            <a:off x="4415583" y="5410200"/>
            <a:ext cx="536575" cy="2746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de-DE" altLang="en-US" sz="1200"/>
              <a:t>2 min</a:t>
            </a:r>
          </a:p>
        </p:txBody>
      </p:sp>
      <p:sp>
        <p:nvSpPr>
          <p:cNvPr id="9" name="Rectangle 10"/>
          <p:cNvSpPr>
            <a:spLocks noChangeArrowheads="1"/>
          </p:cNvSpPr>
          <p:nvPr/>
        </p:nvSpPr>
        <p:spPr bwMode="auto">
          <a:xfrm>
            <a:off x="72182" y="762000"/>
            <a:ext cx="4953000" cy="59436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en-US"/>
          </a:p>
        </p:txBody>
      </p:sp>
      <p:sp>
        <p:nvSpPr>
          <p:cNvPr id="10" name="Text Box 11"/>
          <p:cNvSpPr txBox="1">
            <a:spLocks noChangeArrowheads="1"/>
          </p:cNvSpPr>
          <p:nvPr/>
        </p:nvSpPr>
        <p:spPr bwMode="auto">
          <a:xfrm>
            <a:off x="5695107" y="3398839"/>
            <a:ext cx="1677988" cy="2746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de-DE" altLang="en-US" sz="1200"/>
              <a:t>panERK loading control</a:t>
            </a:r>
          </a:p>
        </p:txBody>
      </p:sp>
      <p:pic>
        <p:nvPicPr>
          <p:cNvPr id="12" name="Picture 15" descr="screen2-flag2.jpg                                              001B7507Newton                         C1020127: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982" y="990600"/>
            <a:ext cx="3598863" cy="23447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6" descr="screen2-flag1.jpg                                              001B7507Newton                         C1020127: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9382" y="3962401"/>
            <a:ext cx="3603625" cy="26146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7" descr="screen2-erk.tif                                                001B7507Newton                         C1020127: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3783" y="685801"/>
            <a:ext cx="3598863" cy="26146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032896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5</Words>
  <Application>Microsoft Office PowerPoint</Application>
  <PresentationFormat>Bildschirmpräsentation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Medizinische Universitaet Wi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ITSC</dc:creator>
  <cp:lastModifiedBy>ITSC</cp:lastModifiedBy>
  <cp:revision>1</cp:revision>
  <dcterms:created xsi:type="dcterms:W3CDTF">2023-03-27T21:09:35Z</dcterms:created>
  <dcterms:modified xsi:type="dcterms:W3CDTF">2023-03-27T21:11:53Z</dcterms:modified>
</cp:coreProperties>
</file>